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6858000" cy="12192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44" autoAdjust="0"/>
    <p:restoredTop sz="94660"/>
  </p:normalViewPr>
  <p:slideViewPr>
    <p:cSldViewPr snapToGrid="0">
      <p:cViewPr varScale="1">
        <p:scale>
          <a:sx n="42" d="100"/>
          <a:sy n="42" d="100"/>
        </p:scale>
        <p:origin x="2514"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6C64AF67-6DF8-47B2-A801-D90AF3289AF0}" type="datetimeFigureOut">
              <a:rPr lang="en-US" smtClean="0"/>
              <a:t>10/1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27280883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C64AF67-6DF8-47B2-A801-D90AF3289AF0}" type="datetimeFigureOut">
              <a:rPr lang="en-US" smtClean="0"/>
              <a:t>10/1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25558109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C64AF67-6DF8-47B2-A801-D90AF3289AF0}" type="datetimeFigureOut">
              <a:rPr lang="en-US" smtClean="0"/>
              <a:t>10/1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20608228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C64AF67-6DF8-47B2-A801-D90AF3289AF0}" type="datetimeFigureOut">
              <a:rPr lang="en-US" smtClean="0"/>
              <a:t>10/1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39972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C64AF67-6DF8-47B2-A801-D90AF3289AF0}" type="datetimeFigureOut">
              <a:rPr lang="en-US" smtClean="0"/>
              <a:t>10/18/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12482775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6C64AF67-6DF8-47B2-A801-D90AF3289AF0}" type="datetimeFigureOut">
              <a:rPr lang="en-US" smtClean="0"/>
              <a:t>10/1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24572312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6C64AF67-6DF8-47B2-A801-D90AF3289AF0}" type="datetimeFigureOut">
              <a:rPr lang="en-US" smtClean="0"/>
              <a:t>10/18/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11070902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6C64AF67-6DF8-47B2-A801-D90AF3289AF0}" type="datetimeFigureOut">
              <a:rPr lang="en-US" smtClean="0"/>
              <a:t>10/18/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12435511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64AF67-6DF8-47B2-A801-D90AF3289AF0}" type="datetimeFigureOut">
              <a:rPr lang="en-US" smtClean="0"/>
              <a:t>10/18/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34338624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C64AF67-6DF8-47B2-A801-D90AF3289AF0}" type="datetimeFigureOut">
              <a:rPr lang="en-US" smtClean="0"/>
              <a:t>10/1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14368764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C64AF67-6DF8-47B2-A801-D90AF3289AF0}" type="datetimeFigureOut">
              <a:rPr lang="en-US" smtClean="0"/>
              <a:t>10/18/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6788219-35A2-41E3-905C-1244D6FF0EA5}" type="slidenum">
              <a:rPr lang="en-US" smtClean="0"/>
              <a:t>‹#›</a:t>
            </a:fld>
            <a:endParaRPr lang="en-US"/>
          </a:p>
        </p:txBody>
      </p:sp>
    </p:spTree>
    <p:extLst>
      <p:ext uri="{BB962C8B-B14F-4D97-AF65-F5344CB8AC3E}">
        <p14:creationId xmlns:p14="http://schemas.microsoft.com/office/powerpoint/2010/main" val="41936722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6C64AF67-6DF8-47B2-A801-D90AF3289AF0}" type="datetimeFigureOut">
              <a:rPr lang="en-US" smtClean="0"/>
              <a:t>10/18/2017</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36788219-35A2-41E3-905C-1244D6FF0EA5}" type="slidenum">
              <a:rPr lang="en-US" smtClean="0"/>
              <a:t>‹#›</a:t>
            </a:fld>
            <a:endParaRPr lang="en-US"/>
          </a:p>
        </p:txBody>
      </p:sp>
    </p:spTree>
    <p:extLst>
      <p:ext uri="{BB962C8B-B14F-4D97-AF65-F5344CB8AC3E}">
        <p14:creationId xmlns:p14="http://schemas.microsoft.com/office/powerpoint/2010/main" val="25260796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www.ebi.ac.uk/arrayexpress/" TargetMode="External"/><Relationship Id="rId2" Type="http://schemas.openxmlformats.org/officeDocument/2006/relationships/hyperlink" Target="http://www.affymetrix.com/support/technical/byproduct.affx?product=arab" TargetMode="External"/><Relationship Id="rId1" Type="http://schemas.openxmlformats.org/officeDocument/2006/relationships/slideLayout" Target="../slideLayouts/slideLayout1.xml"/><Relationship Id="rId4" Type="http://schemas.openxmlformats.org/officeDocument/2006/relationships/hyperlink" Target="http://www.bioconductor.org/" TargetMode="Externa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37242" y="144129"/>
            <a:ext cx="6079671" cy="12049452"/>
          </a:xfrm>
          <a:prstGeom prst="rect">
            <a:avLst/>
          </a:prstGeom>
        </p:spPr>
        <p:txBody>
          <a:bodyPr wrap="square">
            <a:spAutoFit/>
          </a:bodyPr>
          <a:lstStyle/>
          <a:p>
            <a:pPr algn="just">
              <a:lnSpc>
                <a:spcPct val="150000"/>
              </a:lnSpc>
              <a:spcAft>
                <a:spcPts val="600"/>
              </a:spcAft>
            </a:pPr>
            <a:r>
              <a:rPr lang="en-US" sz="1400" i="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ctr">
              <a:lnSpc>
                <a:spcPct val="150000"/>
              </a:lnSpc>
              <a:spcAft>
                <a:spcPts val="600"/>
              </a:spcAft>
            </a:pPr>
            <a:r>
              <a:rPr lang="en-US" sz="1600" b="1" dirty="0" smtClean="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Supplemental text</a:t>
            </a:r>
          </a:p>
          <a:p>
            <a:pPr algn="ctr">
              <a:lnSpc>
                <a:spcPct val="150000"/>
              </a:lnSpc>
              <a:spcAft>
                <a:spcPts val="600"/>
              </a:spcAft>
            </a:pPr>
            <a:r>
              <a:rPr lang="en-US" sz="1600" b="1" dirty="0"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Details of meta-analysis and </a:t>
            </a:r>
            <a:r>
              <a:rPr lang="en-US" sz="1600" b="1" smtClean="0">
                <a:solidFill>
                  <a:srgbClr val="000000"/>
                </a:solidFill>
                <a:latin typeface="Arial" panose="020B0604020202020204" pitchFamily="34" charset="0"/>
                <a:ea typeface="Times New Roman" panose="02020603050405020304" pitchFamily="18" charset="0"/>
                <a:cs typeface="Times New Roman" panose="02020603050405020304" pitchFamily="18" charset="0"/>
              </a:rPr>
              <a:t>Stand-alone analysis</a:t>
            </a:r>
            <a:endParaRPr lang="en-US" sz="2000" b="1" dirty="0">
              <a:solidFill>
                <a:srgbClr val="00000A"/>
              </a:solidFill>
              <a:effectLst/>
              <a:latin typeface="Arial" panose="020B0604020202020204" pitchFamily="34" charset="0"/>
              <a:ea typeface="Times New Roman" panose="02020603050405020304" pitchFamily="18" charset="0"/>
              <a:cs typeface="Times New Roman" panose="02020603050405020304" pitchFamily="18" charset="0"/>
            </a:endParaRPr>
          </a:p>
          <a:p>
            <a:pPr algn="just">
              <a:lnSpc>
                <a:spcPct val="150000"/>
              </a:lnSpc>
              <a:spcAft>
                <a:spcPts val="600"/>
              </a:spcAft>
            </a:pP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400"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icroarray </a:t>
            </a:r>
            <a:r>
              <a:rPr lang="en-US" sz="14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a analysis using </a:t>
            </a:r>
            <a:r>
              <a:rPr lang="en-US" sz="1400" b="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enevestigator</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lnSpc>
                <a:spcPct val="150000"/>
              </a:lnSpc>
              <a:spcAft>
                <a:spcPts val="600"/>
              </a:spcAft>
            </a:pPr>
            <a:r>
              <a:rPr lang="en-US" sz="1400" i="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enevestigator</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nables meta-analysis, based on statistical tests to detect differential expression, by combining results from several studies. Expression values for root tissues from </a:t>
            </a:r>
            <a:r>
              <a:rPr lang="en-US" sz="1400" i="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enevestigator</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were considered separately to obtain a list of probe sets preferentially expressing in root tissue. A stringent approach was employed to obtain this list for which specific comparisons were made between each individual root tissue and non-root tissues. Expression data was collected using the ‘Biomarker search tool’ (www.genevestigator.com) from ‘anatomy’ and ‘conditions’ queries to mine root-specific and nematode-responsive probe sets, respectively. Probe sets for each analysis were pooled (different stages or tissues) to identify probe sets that were unique. A database of probes along with their sequence was made using available sequence files (</a:t>
            </a:r>
            <a:r>
              <a:rPr lang="en-US" sz="1400" u="sng"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hlinkClick r:id="rId2"/>
              </a:rPr>
              <a:t>http://www.affymetrix.com/support/technical/byproduct.affx?product=arab</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This database was used to remap probe sets on </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rabidopsis</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CDS (TAIR release 9) and correct ambiguities in corresponding </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rabidopsis</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Gene Identifiers (AGIs). Unique AGIs were selected to avoid redundancy in probe sets of the final </a:t>
            </a:r>
            <a:r>
              <a:rPr lang="en-US" sz="1400"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aset</a:t>
            </a:r>
            <a:r>
              <a:rPr lang="en-US" sz="14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lnSpc>
                <a:spcPct val="150000"/>
              </a:lnSpc>
              <a:spcAft>
                <a:spcPts val="600"/>
              </a:spcAft>
            </a:pPr>
            <a:r>
              <a:rPr lang="en-US" sz="14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nalysis of “</a:t>
            </a:r>
            <a:r>
              <a:rPr lang="en-US" sz="1400" b="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tGenExpress</a:t>
            </a:r>
            <a:r>
              <a:rPr lang="en-US" sz="1400" b="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microarray data using in-house scripts</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lnSpc>
                <a:spcPct val="150000"/>
              </a:lnSpc>
              <a:spcAft>
                <a:spcPts val="600"/>
              </a:spcAft>
            </a:pP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or stand-alone analysis, raw microarray datasets were downloaded for the experiment E-AFMX-9 (</a:t>
            </a:r>
            <a:r>
              <a:rPr lang="en-US" sz="14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chmid</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et al. 2005) from ARRAYEXPRESS (</a:t>
            </a:r>
            <a:r>
              <a:rPr lang="en-US" sz="1400" u="sng"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hlinkClick r:id="rId3"/>
              </a:rPr>
              <a:t>http://www.ebi.ac.uk/arrayexpress/</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nalysis was carried out using the R statistical language (R Core Team, 2011) and </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ioconductor</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400" u="sng"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hlinkClick r:id="rId4"/>
              </a:rPr>
              <a:t>http://www.bioconductor.org/</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packages. Raw files (*.</a:t>
            </a:r>
            <a:r>
              <a:rPr lang="en-US" sz="14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el</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files, n= 237 ) were read using the </a:t>
            </a:r>
            <a:r>
              <a:rPr lang="en-US" sz="1400" i="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ffy</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autier et al. 2004) package and GC Robust Multi-array Average (GCRMA) based background adjustment, inter-chip normalization and summarization was performed. A comparison of root samples was done individually with vegetative stem, inflorescence and leaf samples at three time points (7, 17, and 21 days). Differentially expressed genes for each comparison were identified using </a:t>
            </a:r>
            <a:r>
              <a:rPr lang="en-US" sz="1400" i="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imma</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R” package (Smyth, 2005), which included, fitting a linear model using the ‘</a:t>
            </a:r>
            <a:r>
              <a:rPr lang="en-US" sz="1400" i="1"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lmFit</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function (Smyth, 2004), a moderated t-test followed by correction of p-values using FDR  correction algorithm (</a:t>
            </a:r>
            <a:r>
              <a:rPr lang="en-US" sz="14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enjamini</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nd Hochberg 2001). Probe sets with FC ≥ 4 and a corrected </a:t>
            </a:r>
            <a:r>
              <a:rPr lang="en-US" sz="1400"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a:t>
            </a:r>
            <a:r>
              <a:rPr lang="en-US" sz="14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value ≤0.01 were considered for further analyses. </a:t>
            </a:r>
            <a:endParaRPr lang="en-US"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485499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2" name="Rectangle 1"/>
              <p:cNvSpPr/>
              <p:nvPr/>
            </p:nvSpPr>
            <p:spPr>
              <a:xfrm>
                <a:off x="217715" y="943897"/>
                <a:ext cx="6299200" cy="6856877"/>
              </a:xfrm>
              <a:prstGeom prst="rect">
                <a:avLst/>
              </a:prstGeom>
            </p:spPr>
            <p:txBody>
              <a:bodyPr wrap="square">
                <a:spAutoFit/>
              </a:bodyPr>
              <a:lstStyle/>
              <a:p>
                <a:pPr algn="just">
                  <a:lnSpc>
                    <a:spcPct val="150000"/>
                  </a:lnSpc>
                  <a:spcAft>
                    <a:spcPts val="600"/>
                  </a:spcAft>
                </a:pPr>
                <a:r>
                  <a:rPr lang="en-US" b="1"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dentify genes with low expression level under normal developmental stages</a:t>
                </a:r>
                <a:endParaRPr lang="en-US" sz="16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lnSpc>
                    <a:spcPct val="150000"/>
                  </a:lnSpc>
                  <a:spcAft>
                    <a:spcPts val="600"/>
                  </a:spcAft>
                </a:pP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 mean of average expression intensities for a complete gene-set was computed for every tissue at each time-point considered in stand-alone analysis. This is referred to as </a:t>
                </a:r>
                <a:r>
                  <a:rPr lang="en-US"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lobal-Mean of Average Intensities</a:t>
                </a: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GMAI), and computed as follows:</a:t>
                </a:r>
                <a:endParaRPr lang="en-US" sz="16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lnSpc>
                    <a:spcPct val="150000"/>
                  </a:lnSpc>
                  <a:spcBef>
                    <a:spcPts val="600"/>
                  </a:spcBef>
                  <a:spcAft>
                    <a:spcPts val="600"/>
                  </a:spcAft>
                </a:pP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MAI = </a:t>
                </a:r>
                <a14:m>
                  <m:oMath xmlns:m="http://schemas.openxmlformats.org/officeDocument/2006/math">
                    <m:f>
                      <m:fPr>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fPr>
                      <m:num>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num>
                      <m:den>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𝑇</m:t>
                        </m:r>
                      </m:den>
                    </m:f>
                    <m:nary>
                      <m:naryPr>
                        <m:chr m:val="∑"/>
                        <m:limLoc m:val="undOvr"/>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naryPr>
                      <m:sub>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sub>
                      <m:sup>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𝑇</m:t>
                        </m:r>
                      </m:sup>
                      <m:e>
                        <m:sSub>
                          <m:sSubPr>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𝑍</m:t>
                            </m:r>
                          </m:e>
                          <m:sub>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𝑡</m:t>
                            </m:r>
                          </m:sub>
                        </m:sSub>
                      </m:e>
                    </m:nary>
                  </m:oMath>
                </a14:m>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with </a:t>
                </a:r>
                <a14:m>
                  <m:oMath xmlns:m="http://schemas.openxmlformats.org/officeDocument/2006/math">
                    <m:sSub>
                      <m:sSubPr>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𝑍</m:t>
                        </m:r>
                      </m:e>
                      <m:sub>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𝑡</m:t>
                        </m:r>
                      </m:sub>
                    </m:sSub>
                  </m:oMath>
                </a14:m>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 </a:t>
                </a:r>
                <a14:m>
                  <m:oMath xmlns:m="http://schemas.openxmlformats.org/officeDocument/2006/math">
                    <m:f>
                      <m:fPr>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fPr>
                      <m:num>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1</m:t>
                        </m:r>
                      </m:num>
                      <m:den>
                        <m:d>
                          <m:dPr>
                            <m:begChr m:val="|"/>
                            <m:endChr m:val="|"/>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dPr>
                          <m:e>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𝐺</m:t>
                            </m:r>
                          </m:e>
                        </m:d>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𝑆</m:t>
                        </m:r>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den>
                    </m:f>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 . </m:t>
                    </m:r>
                    <m:nary>
                      <m:naryPr>
                        <m:chr m:val="∑"/>
                        <m:limLoc m:val="subSup"/>
                        <m:supHide m:val="on"/>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naryPr>
                      <m:sub>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𝐺</m:t>
                        </m:r>
                      </m:sub>
                      <m:sup/>
                      <m:e>
                        <m:nary>
                          <m:naryPr>
                            <m:chr m:val="∑"/>
                            <m:limLoc m:val="subSup"/>
                            <m:supHide m:val="on"/>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naryPr>
                          <m:sub>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𝑆</m:t>
                            </m:r>
                          </m:sub>
                          <m:sup/>
                          <m:e>
                            <m:sSub>
                              <m:sSubPr>
                                <m:ctrlP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ctrlPr>
                              </m:sSubPr>
                              <m:e>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𝑥</m:t>
                                </m:r>
                              </m:e>
                              <m:sub>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𝑖</m:t>
                                </m:r>
                                <m:r>
                                  <a:rPr lang="en-US">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m:t>
                                </m:r>
                                <m:r>
                                  <a:rPr lang="en-US" i="1">
                                    <a:solidFill>
                                      <a:srgbClr val="000000"/>
                                    </a:solidFill>
                                    <a:effectLst/>
                                    <a:latin typeface="Cambria Math" panose="02040503050406030204" pitchFamily="18" charset="0"/>
                                    <a:ea typeface="Times New Roman" panose="02020603050405020304" pitchFamily="18" charset="0"/>
                                    <a:cs typeface="Times New Roman" panose="02020603050405020304" pitchFamily="18" charset="0"/>
                                  </a:rPr>
                                  <m:t>𝑗</m:t>
                                </m:r>
                              </m:sub>
                            </m:sSub>
                          </m:e>
                        </m:nary>
                      </m:e>
                    </m:nary>
                  </m:oMath>
                </a14:m>
                <a:endParaRPr lang="en-US" sz="16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lnSpc>
                    <a:spcPct val="150000"/>
                  </a:lnSpc>
                </a:pP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here, </a:t>
                </a:r>
                <a:r>
                  <a:rPr lang="en-US"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Z</a:t>
                </a:r>
                <a:r>
                  <a:rPr lang="en-US" baseline="-250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a:t>
                </a:r>
                <a:r>
                  <a:rPr lang="en-US" baseline="-25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s the </a:t>
                </a:r>
                <a:r>
                  <a:rPr lang="en-US"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AI</a:t>
                </a: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time-point ‘T’. ‘G’ is the gene-set on microarray chip, ‘S’ is the sample and ‘x’ is the expression intensity of a gene. In absence of any earlier report with a similar global expression intensity based filter, an arbitrary cut-off of expression intensity ≤ 0.5 </a:t>
                </a:r>
                <a:r>
                  <a:rPr lang="en-US"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GMAI</a:t>
                </a: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was imposed to filter genes with low basal intensity (LBI) i.e. expression level under normal developmental stages. Six genes passed the filter and were considered for </a:t>
                </a:r>
                <a:r>
                  <a:rPr lang="en-US" i="1"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is</a:t>
                </a:r>
                <a:r>
                  <a:rPr lang="en-US"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lement based screening. </a:t>
                </a:r>
                <a:endParaRPr lang="en-US" sz="1600" dirty="0">
                  <a:effectLst/>
                  <a:latin typeface="Calibri" panose="020F0502020204030204" pitchFamily="34" charset="0"/>
                  <a:ea typeface="Times New Roman" panose="02020603050405020304" pitchFamily="18" charset="0"/>
                  <a:cs typeface="Times New Roman" panose="02020603050405020304" pitchFamily="18" charset="0"/>
                </a:endParaRPr>
              </a:p>
            </p:txBody>
          </p:sp>
        </mc:Choice>
        <mc:Fallback xmlns="">
          <p:sp>
            <p:nvSpPr>
              <p:cNvPr id="2" name="Rectangle 1"/>
              <p:cNvSpPr>
                <a:spLocks noRot="1" noChangeAspect="1" noMove="1" noResize="1" noEditPoints="1" noAdjustHandles="1" noChangeArrowheads="1" noChangeShapeType="1" noTextEdit="1"/>
              </p:cNvSpPr>
              <p:nvPr/>
            </p:nvSpPr>
            <p:spPr>
              <a:xfrm>
                <a:off x="217715" y="943897"/>
                <a:ext cx="6299200" cy="6856877"/>
              </a:xfrm>
              <a:prstGeom prst="rect">
                <a:avLst/>
              </a:prstGeom>
              <a:blipFill rotWithShape="0">
                <a:blip r:embed="rId2"/>
                <a:stretch>
                  <a:fillRect l="-871" r="-774"/>
                </a:stretch>
              </a:blipFill>
            </p:spPr>
            <p:txBody>
              <a:bodyPr/>
              <a:lstStyle/>
              <a:p>
                <a:r>
                  <a:rPr lang="en-US">
                    <a:noFill/>
                  </a:rPr>
                  <a:t> </a:t>
                </a:r>
              </a:p>
            </p:txBody>
          </p:sp>
        </mc:Fallback>
      </mc:AlternateContent>
    </p:spTree>
    <p:extLst>
      <p:ext uri="{BB962C8B-B14F-4D97-AF65-F5344CB8AC3E}">
        <p14:creationId xmlns:p14="http://schemas.microsoft.com/office/powerpoint/2010/main" val="36626648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1.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1.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4ECF5FCF-7AE8-4EB1-A687-190FD6C77D10}"/>
</file>

<file path=customXml/itemProps2.xml><?xml version="1.0" encoding="utf-8"?>
<ds:datastoreItem xmlns:ds="http://schemas.openxmlformats.org/officeDocument/2006/customXml" ds:itemID="{978FEF67-E9A6-4E4D-A4FE-674684567B9B}"/>
</file>

<file path=customXml/itemProps3.xml><?xml version="1.0" encoding="utf-8"?>
<ds:datastoreItem xmlns:ds="http://schemas.openxmlformats.org/officeDocument/2006/customXml" ds:itemID="{7FAF8581-A4A5-4E32-BAA0-5B532EA1190F}"/>
</file>

<file path=docProps/app.xml><?xml version="1.0" encoding="utf-8"?>
<Properties xmlns="http://schemas.openxmlformats.org/officeDocument/2006/extended-properties" xmlns:vt="http://schemas.openxmlformats.org/officeDocument/2006/docPropsVTypes">
  <Template>Office Theme</Template>
  <TotalTime>2</TotalTime>
  <Words>52</Words>
  <Application>Microsoft Office PowerPoint</Application>
  <PresentationFormat>Widescreen</PresentationFormat>
  <Paragraphs>11</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rial</vt:lpstr>
      <vt:lpstr>Calibri</vt:lpstr>
      <vt:lpstr>Calibri Light</vt:lpstr>
      <vt:lpstr>Cambria Math</vt:lpstr>
      <vt:lpstr>Times New Roman</vt:lpstr>
      <vt:lpstr>Office Theme</vt:lpstr>
      <vt:lpstr>PowerPoint Presentation</vt:lpstr>
      <vt:lpstr>PowerPoint Presentation</vt:lpstr>
    </vt:vector>
  </TitlesOfParts>
  <Company>Microsoft</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dc:creator>
  <cp:lastModifiedBy>Microsoft</cp:lastModifiedBy>
  <cp:revision>3</cp:revision>
  <dcterms:created xsi:type="dcterms:W3CDTF">2017-10-17T19:02:17Z</dcterms:created>
  <dcterms:modified xsi:type="dcterms:W3CDTF">2017-10-17T19:15:16Z</dcterms:modified>
</cp:coreProperties>
</file>